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1993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57" autoAdjust="0"/>
    <p:restoredTop sz="89247" autoAdjust="0"/>
  </p:normalViewPr>
  <p:slideViewPr>
    <p:cSldViewPr snapToGrid="0">
      <p:cViewPr varScale="1">
        <p:scale>
          <a:sx n="69" d="100"/>
          <a:sy n="69" d="100"/>
        </p:scale>
        <p:origin x="3952" y="192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359AD5-3FD2-4334-AA43-651A615B5D64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07AF3E-E226-44AD-A662-4E32329D5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3270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07AF3E-E226-44AD-A662-4E32329D5F7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270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767462"/>
            <a:ext cx="6119416" cy="375991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5672376"/>
            <a:ext cx="5399485" cy="260744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151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01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574987"/>
            <a:ext cx="1552352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574987"/>
            <a:ext cx="4567064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387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5057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692444"/>
            <a:ext cx="6209407" cy="449240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7227345"/>
            <a:ext cx="6209407" cy="236244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993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58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574990"/>
            <a:ext cx="6209407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647443"/>
            <a:ext cx="3045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944914"/>
            <a:ext cx="3045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647443"/>
            <a:ext cx="3060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944914"/>
            <a:ext cx="3060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079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1655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837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554968"/>
            <a:ext cx="3644652" cy="767483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671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554968"/>
            <a:ext cx="3644652" cy="767483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148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574990"/>
            <a:ext cx="6209407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874937"/>
            <a:ext cx="6209407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ED8AAB-7D0B-5748-A01D-84D2C63BF5B9}" type="datetimeFigureOut">
              <a:rPr kumimoji="1" lang="ja-JP" altLang="en-US" smtClean="0"/>
              <a:t>2024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0009783"/>
            <a:ext cx="242976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F3D970-5640-CD4C-ADC4-0D99D0AA82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392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FAAECB7-0CFF-5772-9DC6-CA5BCF5CE4B3}"/>
              </a:ext>
            </a:extLst>
          </p:cNvPr>
          <p:cNvSpPr txBox="1"/>
          <p:nvPr/>
        </p:nvSpPr>
        <p:spPr>
          <a:xfrm>
            <a:off x="364671" y="275550"/>
            <a:ext cx="66251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table 3. </a:t>
            </a:r>
          </a:p>
          <a:p>
            <a:pPr algn="just"/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thod of calculating economic loss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4" name="フリーフォーム: 図形 83">
            <a:extLst>
              <a:ext uri="{FF2B5EF4-FFF2-40B4-BE49-F238E27FC236}">
                <a16:creationId xmlns:a16="http://schemas.microsoft.com/office/drawing/2014/main" id="{F6C0E69B-5E6E-5526-12F8-ED670F906BBE}"/>
              </a:ext>
            </a:extLst>
          </p:cNvPr>
          <p:cNvSpPr/>
          <p:nvPr/>
        </p:nvSpPr>
        <p:spPr>
          <a:xfrm>
            <a:off x="131567" y="924905"/>
            <a:ext cx="6858207" cy="1208239"/>
          </a:xfrm>
          <a:custGeom>
            <a:avLst/>
            <a:gdLst>
              <a:gd name="connsiteX0" fmla="*/ 0 w 6524082"/>
              <a:gd name="connsiteY0" fmla="*/ 0 h 488935"/>
              <a:gd name="connsiteX1" fmla="*/ 6524083 w 6524082"/>
              <a:gd name="connsiteY1" fmla="*/ 0 h 488935"/>
              <a:gd name="connsiteX2" fmla="*/ 6524083 w 6524082"/>
              <a:gd name="connsiteY2" fmla="*/ 488936 h 488935"/>
              <a:gd name="connsiteX3" fmla="*/ 0 w 6524082"/>
              <a:gd name="connsiteY3" fmla="*/ 488936 h 488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4082" h="488935">
                <a:moveTo>
                  <a:pt x="0" y="0"/>
                </a:moveTo>
                <a:lnTo>
                  <a:pt x="6524083" y="0"/>
                </a:lnTo>
                <a:lnTo>
                  <a:pt x="6524083" y="488936"/>
                </a:lnTo>
                <a:lnTo>
                  <a:pt x="0" y="488936"/>
                </a:lnTo>
                <a:close/>
              </a:path>
            </a:pathLst>
          </a:custGeom>
          <a:noFill/>
          <a:ln w="701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5909ED3-88CF-FDBF-1121-03EDFD474BD7}"/>
              </a:ext>
            </a:extLst>
          </p:cNvPr>
          <p:cNvSpPr txBox="1"/>
          <p:nvPr/>
        </p:nvSpPr>
        <p:spPr>
          <a:xfrm>
            <a:off x="183420" y="932816"/>
            <a:ext cx="68291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hourly wage:</a:t>
            </a:r>
          </a:p>
          <a:p>
            <a:pPr algn="just"/>
            <a:endParaRPr lang="en-US" altLang="ja-JP" sz="12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tient’s hourly wage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(Patient’s annual income in 2019) / ((hours patient is expected to work per month at 12 months post-COVID-19 diagnosis) x 12))	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• • •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quation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5)</a:t>
            </a:r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6" name="フリーフォーム: 図形 15">
            <a:extLst>
              <a:ext uri="{FF2B5EF4-FFF2-40B4-BE49-F238E27FC236}">
                <a16:creationId xmlns:a16="http://schemas.microsoft.com/office/drawing/2014/main" id="{01729EAB-5E88-7485-F37C-86A69CE2E4BA}"/>
              </a:ext>
            </a:extLst>
          </p:cNvPr>
          <p:cNvSpPr/>
          <p:nvPr/>
        </p:nvSpPr>
        <p:spPr>
          <a:xfrm>
            <a:off x="131566" y="2342545"/>
            <a:ext cx="6858205" cy="8032968"/>
          </a:xfrm>
          <a:custGeom>
            <a:avLst/>
            <a:gdLst>
              <a:gd name="connsiteX0" fmla="*/ 0 w 6524082"/>
              <a:gd name="connsiteY0" fmla="*/ 0 h 488935"/>
              <a:gd name="connsiteX1" fmla="*/ 6524083 w 6524082"/>
              <a:gd name="connsiteY1" fmla="*/ 0 h 488935"/>
              <a:gd name="connsiteX2" fmla="*/ 6524083 w 6524082"/>
              <a:gd name="connsiteY2" fmla="*/ 488936 h 488935"/>
              <a:gd name="connsiteX3" fmla="*/ 0 w 6524082"/>
              <a:gd name="connsiteY3" fmla="*/ 488936 h 488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4082" h="488935">
                <a:moveTo>
                  <a:pt x="0" y="0"/>
                </a:moveTo>
                <a:lnTo>
                  <a:pt x="6524083" y="0"/>
                </a:lnTo>
                <a:lnTo>
                  <a:pt x="6524083" y="488936"/>
                </a:lnTo>
                <a:lnTo>
                  <a:pt x="0" y="488936"/>
                </a:lnTo>
                <a:close/>
              </a:path>
            </a:pathLst>
          </a:custGeom>
          <a:noFill/>
          <a:ln w="701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8A036A9-E53C-1B7E-204A-5726B4DC165F}"/>
              </a:ext>
            </a:extLst>
          </p:cNvPr>
          <p:cNvSpPr txBox="1"/>
          <p:nvPr/>
        </p:nvSpPr>
        <p:spPr>
          <a:xfrm>
            <a:off x="131568" y="2396452"/>
            <a:ext cx="6858206" cy="8032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onetary conversion method for economic losses: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conomic loss as a result of labor productivity decline)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(Economic loss as a result of absolute presenteeism) + (Economic loss as a result of absolute absenteeism)</a:t>
            </a:r>
          </a:p>
          <a:p>
            <a:pPr algn="just"/>
            <a:endParaRPr lang="en-US" altLang="ja-JP" sz="12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as a result of absolute presenteeism: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a patient with long-COVID at 3 months post-COVID-19 diagnosis = A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a patient with long-COVID at 6 months post-COVID-19 diagnosis = A + B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a patient with long-COVID at 12 months post-COVID-19 diagnosis = A + B + C</a:t>
            </a:r>
          </a:p>
          <a:p>
            <a:pPr algn="just"/>
            <a:endParaRPr lang="en-US" altLang="ja-JP" sz="12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ecifically, at m months after COVID-19 diagnosis for m = 3, 6, 12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 = (hourly wage) × (hours lost as a result of absolute presenteeism during the period with long-COVID)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(hourly wage) × (actual hours worked in a month reported at m) × 3 × (absolute presenteeism loss at m/100)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Equation (5) × ((Q3 evaluated at m) - (Equation (3) evaluated at m)) × 3 ×(1- (Equation (1) evaluated at m)),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here m = 3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= Equation (5) × ((Q3 evaluated at m) - (Equation (3) evaluated at m)) × 3 ×(1- (Equation (1) evaluated at m)),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here m = 6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= Equation (5) × ((Q3 evaluated at m) - (Equation (3) evaluated at m)) × 6×(1-(Equation (1) evaluated at m)),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here m = 12 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owing to absolute absenteeism: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patients with long-COVID at 3 months post-COVID-19 diagnosis = D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patients with long-COVID at 6 months post-COVID-19 diagnosis = D + E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onomic loss for patients with long-COVID at 12 months post-COVID-19 diagnosis = D + E + F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ecifically, at m months after COVID-19 diagnosis for m = 3, 6, 12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 = (hourly wage) ×(actual hours missed) 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(hourly wage)×(absolute absenteeism at m)× 3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Equation (5) × (Equation (3) evaluated at m) × 3, where m = 3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 = Equation (5) × (Equation (3) evaluated at m) × 3, where m = 6</a:t>
            </a: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 = Equation (5) × (Equation (3) evaluated at m) × 6, where m = 12</a:t>
            </a:r>
          </a:p>
          <a:p>
            <a:pPr algn="just"/>
            <a:endParaRPr lang="en-US" altLang="ja-JP" sz="12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ote that when absolute absenteeism &lt; 0 indicated overtime work, 0 was substituted as the actual hours worked were not reduced. </a:t>
            </a:r>
          </a:p>
        </p:txBody>
      </p:sp>
    </p:spTree>
    <p:extLst>
      <p:ext uri="{BB962C8B-B14F-4D97-AF65-F5344CB8AC3E}">
        <p14:creationId xmlns:p14="http://schemas.microsoft.com/office/powerpoint/2010/main" val="3745372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63</TotalTime>
  <Words>517</Words>
  <Application>Microsoft Macintosh PowerPoint</Application>
  <PresentationFormat>ユーザー設定</PresentationFormat>
  <Paragraphs>4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木 克宜</dc:creator>
  <cp:lastModifiedBy>Katsunori Masaki</cp:lastModifiedBy>
  <cp:revision>10</cp:revision>
  <dcterms:created xsi:type="dcterms:W3CDTF">2024-03-15T15:51:48Z</dcterms:created>
  <dcterms:modified xsi:type="dcterms:W3CDTF">2024-09-23T15:12:22Z</dcterms:modified>
</cp:coreProperties>
</file>